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05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0D3293-D2CE-4368-8D61-BC47B1B966CD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64169D-5BCB-4194-ABDA-DDFC9164013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21003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8524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0945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7183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69925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01723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66754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6721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8533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3984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7427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8517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4579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ZoneTexte 10"/>
          <p:cNvSpPr txBox="1"/>
          <p:nvPr/>
        </p:nvSpPr>
        <p:spPr>
          <a:xfrm>
            <a:off x="0" y="14421"/>
            <a:ext cx="2541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Figure 4</a:t>
            </a:r>
            <a:endParaRPr lang="fr-FR" dirty="0"/>
          </a:p>
        </p:txBody>
      </p:sp>
      <p:grpSp>
        <p:nvGrpSpPr>
          <p:cNvPr id="2" name="Groupe 1"/>
          <p:cNvGrpSpPr/>
          <p:nvPr/>
        </p:nvGrpSpPr>
        <p:grpSpPr>
          <a:xfrm>
            <a:off x="2413511" y="69067"/>
            <a:ext cx="6352220" cy="6923336"/>
            <a:chOff x="2413511" y="69067"/>
            <a:chExt cx="6352220" cy="6923336"/>
          </a:xfrm>
        </p:grpSpPr>
        <p:pic>
          <p:nvPicPr>
            <p:cNvPr id="25" name="Picture 4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144" r="72710" b="13648"/>
            <a:stretch/>
          </p:blipFill>
          <p:spPr bwMode="auto">
            <a:xfrm>
              <a:off x="2541443" y="322501"/>
              <a:ext cx="2200276" cy="342082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6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980" r="73537" b="23132"/>
            <a:stretch/>
          </p:blipFill>
          <p:spPr bwMode="auto">
            <a:xfrm>
              <a:off x="2541443" y="3809999"/>
              <a:ext cx="2133601" cy="30003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7" name="ZoneTexte 26"/>
            <p:cNvSpPr txBox="1"/>
            <p:nvPr/>
          </p:nvSpPr>
          <p:spPr>
            <a:xfrm>
              <a:off x="4641406" y="297335"/>
              <a:ext cx="4124325" cy="35609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pleckstrin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omology-like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domain </a:t>
              </a:r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1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ecrosis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factor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ember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utative </a:t>
              </a:r>
              <a:r>
                <a:rPr lang="fr-FR" sz="962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poptosis-associated</a:t>
              </a:r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peck</a:t>
              </a:r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protein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euroepithelial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ell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ransforming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ornithine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ecarboxylase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yclin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2</a:t>
              </a:r>
            </a:p>
            <a:p>
              <a:r>
                <a:rPr lang="fr-FR" sz="962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ensin</a:t>
              </a:r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r>
                <a:rPr lang="fr-FR" sz="962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arly</a:t>
              </a:r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rowth</a:t>
              </a:r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sponse</a:t>
              </a:r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  <a:endParaRPr lang="fr-FR" sz="96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olfactomedin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4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estrin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hrombospondin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GFB-</a:t>
              </a:r>
              <a:r>
                <a:rPr lang="fr-FR" sz="962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nduced</a:t>
              </a:r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factor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omeobox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yippee-like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alt-inducible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kinase 1</a:t>
              </a:r>
            </a:p>
            <a:p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DNA-damage-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ducible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ranscript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4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gulator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of G-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gnaling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ruppel-like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factor 2</a:t>
              </a:r>
            </a:p>
            <a:p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ras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omolog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ene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family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ember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B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even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in absentia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omolog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ecrosis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factor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ember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15</a:t>
              </a:r>
              <a:endParaRPr lang="en-US" sz="96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ysteine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-serine-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ich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uclear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protein 1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rowth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rrest-specific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</a:p>
            <a:p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RIGN1 &amp; YY1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inding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endParaRPr lang="fr-FR" sz="962" dirty="0"/>
            </a:p>
          </p:txBody>
        </p:sp>
        <p:sp>
          <p:nvSpPr>
            <p:cNvPr id="28" name="ZoneTexte 27"/>
            <p:cNvSpPr txBox="1"/>
            <p:nvPr/>
          </p:nvSpPr>
          <p:spPr>
            <a:xfrm>
              <a:off x="3084367" y="69067"/>
              <a:ext cx="21395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 smtClean="0">
                  <a:latin typeface="Arial" pitchFamily="34" charset="0"/>
                  <a:cs typeface="Arial" pitchFamily="34" charset="0"/>
                </a:rPr>
                <a:t> 6h     12h    18h    24h</a:t>
              </a:r>
              <a:endParaRPr lang="fr-FR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ZoneTexte 28"/>
            <p:cNvSpPr txBox="1"/>
            <p:nvPr/>
          </p:nvSpPr>
          <p:spPr>
            <a:xfrm>
              <a:off x="4641406" y="3790949"/>
              <a:ext cx="4124325" cy="3201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uclear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ceptor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ubfamily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A2</a:t>
              </a:r>
            </a:p>
            <a:p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zinc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finger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protein </a:t>
              </a:r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 C3H type</a:t>
              </a:r>
              <a:endParaRPr lang="fr-FR" sz="96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sphingosine-1-phosphate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ceptor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polipoprotein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L domain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ntaining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biquitin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pecific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peptidase 2</a:t>
              </a:r>
              <a:endParaRPr lang="en-US" sz="96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zinc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finger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protein 703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erum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lucocorticoid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gulated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kinase 1</a:t>
              </a:r>
            </a:p>
            <a:p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v-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l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ticuloendotheliosis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viral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oncogene</a:t>
              </a:r>
              <a:endParaRPr lang="fr-FR" sz="96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TNFAIP3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teracting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protein 2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eme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oxygenase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sulin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ceptor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ubstrate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olymerization-promoting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protein </a:t>
              </a:r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LR </a:t>
              </a:r>
              <a:r>
                <a:rPr lang="fr-FR" sz="962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family</a:t>
              </a:r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poptosis</a:t>
              </a:r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nhibitory</a:t>
              </a:r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protein</a:t>
              </a:r>
              <a:endParaRPr lang="fr-FR" sz="96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-</a:t>
              </a:r>
              <a:r>
                <a:rPr lang="fr-FR" sz="962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ell</a:t>
              </a:r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LL/</a:t>
              </a:r>
              <a:r>
                <a:rPr lang="fr-FR" sz="962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ymphoma</a:t>
              </a:r>
              <a:r>
                <a:rPr lang="fr-FR" sz="962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6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erpin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peptidase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hibitor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E1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hibin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beta A</a:t>
              </a: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alcyphosine</a:t>
              </a:r>
              <a:endParaRPr lang="fr-FR" sz="96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pithelial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itogen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omolog</a:t>
              </a:r>
              <a:endParaRPr lang="fr-FR" sz="96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N-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cylsphingosine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midohydrolase</a:t>
              </a:r>
              <a:endParaRPr lang="fr-FR" sz="96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sulin-like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rowth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factor </a:t>
              </a:r>
              <a:r>
                <a:rPr lang="fr-FR" sz="962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inding</a:t>
              </a:r>
              <a:r>
                <a:rPr lang="fr-FR" sz="962" b="1" dirty="0">
                  <a:latin typeface="Arial" panose="020B0604020202020204" pitchFamily="34" charset="0"/>
                  <a:cs typeface="Arial" panose="020B0604020202020204" pitchFamily="34" charset="0"/>
                </a:rPr>
                <a:t> protein 1</a:t>
              </a:r>
            </a:p>
            <a:p>
              <a:endParaRPr lang="fr-FR" sz="96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2519386" y="137831"/>
              <a:ext cx="406892" cy="340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b="1" dirty="0" smtClean="0">
                  <a:latin typeface="Arial" pitchFamily="34" charset="0"/>
                  <a:cs typeface="Arial" pitchFamily="34" charset="0"/>
                </a:rPr>
                <a:t> A</a:t>
              </a:r>
              <a:endParaRPr lang="fr-FR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ZoneTexte 30"/>
            <p:cNvSpPr txBox="1"/>
            <p:nvPr/>
          </p:nvSpPr>
          <p:spPr>
            <a:xfrm>
              <a:off x="2511335" y="3652030"/>
              <a:ext cx="406892" cy="340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b="1" dirty="0" smtClean="0">
                  <a:latin typeface="Arial" pitchFamily="34" charset="0"/>
                  <a:cs typeface="Arial" pitchFamily="34" charset="0"/>
                </a:rPr>
                <a:t> B</a:t>
              </a:r>
              <a:endParaRPr lang="fr-FR" sz="1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2" name="Groupe 31"/>
            <p:cNvGrpSpPr/>
            <p:nvPr/>
          </p:nvGrpSpPr>
          <p:grpSpPr>
            <a:xfrm>
              <a:off x="2413511" y="382156"/>
              <a:ext cx="433906" cy="1213444"/>
              <a:chOff x="4251965" y="1632892"/>
              <a:chExt cx="716329" cy="2003240"/>
            </a:xfrm>
          </p:grpSpPr>
          <p:pic>
            <p:nvPicPr>
              <p:cNvPr id="33" name="Image 32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631" t="-231" r="65550" b="97802"/>
              <a:stretch/>
            </p:blipFill>
            <p:spPr>
              <a:xfrm rot="5400000">
                <a:off x="3903577" y="2571415"/>
                <a:ext cx="1929063" cy="200371"/>
              </a:xfrm>
              <a:prstGeom prst="rect">
                <a:avLst/>
              </a:prstGeom>
            </p:spPr>
          </p:pic>
          <p:sp>
            <p:nvSpPr>
              <p:cNvPr id="34" name="ZoneTexte 33"/>
              <p:cNvSpPr txBox="1"/>
              <p:nvPr/>
            </p:nvSpPr>
            <p:spPr>
              <a:xfrm>
                <a:off x="4251965" y="1632892"/>
                <a:ext cx="380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smtClean="0"/>
                  <a:t>0.2</a:t>
                </a:r>
                <a:endParaRPr lang="en-US" sz="1200" b="1" dirty="0"/>
              </a:p>
            </p:txBody>
          </p:sp>
          <p:sp>
            <p:nvSpPr>
              <p:cNvPr id="35" name="ZoneTexte 34"/>
              <p:cNvSpPr txBox="1"/>
              <p:nvPr/>
            </p:nvSpPr>
            <p:spPr>
              <a:xfrm>
                <a:off x="4251965" y="2407305"/>
                <a:ext cx="380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smtClean="0"/>
                  <a:t>1.0</a:t>
                </a:r>
                <a:endParaRPr lang="en-US" sz="1200" b="1" dirty="0"/>
              </a:p>
            </p:txBody>
          </p:sp>
          <p:sp>
            <p:nvSpPr>
              <p:cNvPr id="36" name="ZoneTexte 35"/>
              <p:cNvSpPr txBox="1"/>
              <p:nvPr/>
            </p:nvSpPr>
            <p:spPr>
              <a:xfrm>
                <a:off x="4251965" y="3181721"/>
                <a:ext cx="380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smtClean="0"/>
                  <a:t>5.0</a:t>
                </a:r>
                <a:endParaRPr lang="en-US" sz="1200" b="1" dirty="0"/>
              </a:p>
            </p:txBody>
          </p:sp>
        </p:grpSp>
        <p:grpSp>
          <p:nvGrpSpPr>
            <p:cNvPr id="37" name="Groupe 36"/>
            <p:cNvGrpSpPr/>
            <p:nvPr/>
          </p:nvGrpSpPr>
          <p:grpSpPr>
            <a:xfrm>
              <a:off x="2424136" y="3906461"/>
              <a:ext cx="433906" cy="1213444"/>
              <a:chOff x="4251965" y="1632892"/>
              <a:chExt cx="716329" cy="2003240"/>
            </a:xfrm>
          </p:grpSpPr>
          <p:pic>
            <p:nvPicPr>
              <p:cNvPr id="38" name="Image 37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631" t="-231" r="65550" b="97802"/>
              <a:stretch/>
            </p:blipFill>
            <p:spPr>
              <a:xfrm rot="5400000">
                <a:off x="3903577" y="2571415"/>
                <a:ext cx="1929063" cy="200371"/>
              </a:xfrm>
              <a:prstGeom prst="rect">
                <a:avLst/>
              </a:prstGeom>
            </p:spPr>
          </p:pic>
          <p:sp>
            <p:nvSpPr>
              <p:cNvPr id="39" name="ZoneTexte 38"/>
              <p:cNvSpPr txBox="1"/>
              <p:nvPr/>
            </p:nvSpPr>
            <p:spPr>
              <a:xfrm>
                <a:off x="4251965" y="1632892"/>
                <a:ext cx="380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smtClean="0"/>
                  <a:t>0.2</a:t>
                </a:r>
                <a:endParaRPr lang="en-US" sz="1200" b="1" dirty="0"/>
              </a:p>
            </p:txBody>
          </p:sp>
          <p:sp>
            <p:nvSpPr>
              <p:cNvPr id="40" name="ZoneTexte 39"/>
              <p:cNvSpPr txBox="1"/>
              <p:nvPr/>
            </p:nvSpPr>
            <p:spPr>
              <a:xfrm>
                <a:off x="4251965" y="2407305"/>
                <a:ext cx="380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smtClean="0"/>
                  <a:t>1.0</a:t>
                </a:r>
                <a:endParaRPr lang="en-US" sz="1200" b="1" dirty="0"/>
              </a:p>
            </p:txBody>
          </p:sp>
          <p:sp>
            <p:nvSpPr>
              <p:cNvPr id="41" name="ZoneTexte 40"/>
              <p:cNvSpPr txBox="1"/>
              <p:nvPr/>
            </p:nvSpPr>
            <p:spPr>
              <a:xfrm>
                <a:off x="4251965" y="3181721"/>
                <a:ext cx="380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smtClean="0"/>
                  <a:t>5.0</a:t>
                </a:r>
                <a:endParaRPr lang="en-US" sz="1200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46345165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75</Words>
  <Application>Microsoft Office PowerPoint</Application>
  <PresentationFormat>Affichage à l'écran (4:3)</PresentationFormat>
  <Paragraphs>5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eynaust</dc:creator>
  <cp:lastModifiedBy>reynaust</cp:lastModifiedBy>
  <cp:revision>9</cp:revision>
  <dcterms:created xsi:type="dcterms:W3CDTF">2014-04-05T14:43:45Z</dcterms:created>
  <dcterms:modified xsi:type="dcterms:W3CDTF">2014-04-05T14:54:26Z</dcterms:modified>
</cp:coreProperties>
</file>